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1" autoAdjust="0"/>
    <p:restoredTop sz="94660"/>
  </p:normalViewPr>
  <p:slideViewPr>
    <p:cSldViewPr snapToGrid="0">
      <p:cViewPr>
        <p:scale>
          <a:sx n="66" d="100"/>
          <a:sy n="66" d="100"/>
        </p:scale>
        <p:origin x="1674" y="-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5284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079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4572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432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7588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27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0851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479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429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6581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367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BFA14-BC11-4249-8EEC-F497716F0714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E0AFC-D3BC-4FC5-8EF3-A91943DCB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7680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E8A2ADF2-2D74-4D91-B1C2-507DD59B9F53}"/>
              </a:ext>
            </a:extLst>
          </p:cNvPr>
          <p:cNvSpPr txBox="1"/>
          <p:nvPr/>
        </p:nvSpPr>
        <p:spPr>
          <a:xfrm>
            <a:off x="1106667" y="446052"/>
            <a:ext cx="433913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1 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st of hairpin sequences used in the study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4502DE6-AE6E-4A8F-9678-3B777015B009}"/>
              </a:ext>
            </a:extLst>
          </p:cNvPr>
          <p:cNvSpPr txBox="1"/>
          <p:nvPr/>
        </p:nvSpPr>
        <p:spPr>
          <a:xfrm>
            <a:off x="1099047" y="4295401"/>
            <a:ext cx="44785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2 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st of primer sequences utilized in the study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9B5DA828-DE85-4099-82A0-46CD489F16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4547593"/>
              </p:ext>
            </p:extLst>
          </p:nvPr>
        </p:nvGraphicFramePr>
        <p:xfrm>
          <a:off x="1099047" y="738440"/>
          <a:ext cx="4883785" cy="3352800"/>
        </p:xfrm>
        <a:graphic>
          <a:graphicData uri="http://schemas.openxmlformats.org/drawingml/2006/table">
            <a:tbl>
              <a:tblPr firstRow="1" firstCol="1" bandRow="1"/>
              <a:tblGrid>
                <a:gridCol w="1091703">
                  <a:extLst>
                    <a:ext uri="{9D8B030D-6E8A-4147-A177-3AD203B41FA5}">
                      <a16:colId xmlns:a16="http://schemas.microsoft.com/office/drawing/2014/main" val="2400878077"/>
                    </a:ext>
                  </a:extLst>
                </a:gridCol>
                <a:gridCol w="3792082">
                  <a:extLst>
                    <a:ext uri="{9D8B030D-6E8A-4147-A177-3AD203B41FA5}">
                      <a16:colId xmlns:a16="http://schemas.microsoft.com/office/drawing/2014/main" val="311274703"/>
                    </a:ext>
                  </a:extLst>
                </a:gridCol>
              </a:tblGrid>
              <a:tr h="436245">
                <a:tc>
                  <a:txBody>
                    <a:bodyPr/>
                    <a:lstStyle/>
                    <a:p>
                      <a:pPr algn="l"/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rge</a:t>
                      </a:r>
                      <a:r>
                        <a:rPr lang="en-US" altLang="zh-CN" sz="12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gene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hRNA sequences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1382277"/>
                  </a:ext>
                </a:extLst>
              </a:tr>
              <a:tr h="487045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hCtrl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’-TTCTCCGAACGTGTCACGT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’-ACGTGACACGTTCGGAGAA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7400141"/>
                  </a:ext>
                </a:extLst>
              </a:tr>
              <a:tr h="487045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LC6A8#1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’-CAGAUGGACUUCAUCAUGUTT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‘-ACAUGAUGAAGUCCAUCUGTT-3‘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8495691"/>
                  </a:ext>
                </a:extLst>
              </a:tr>
              <a:tr h="487045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LC6A8#2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’-CCAUCAUCCUGGCUCUCAUTT-3’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’-AUGAGAGCCAGGAUGAUGGTT3’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4508550"/>
                  </a:ext>
                </a:extLst>
              </a:tr>
              <a:tr h="478790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F-</a:t>
                      </a:r>
                      <a:r>
                        <a:rPr lang="en-US" sz="12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κB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’-CCUGCAGUUUGAUGCUGAUTT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’-AUCAGCAUCAAACUGCAGGTT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9760211"/>
                  </a:ext>
                </a:extLst>
              </a:tr>
              <a:tr h="488315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A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′- TACGTTGTGAGTGGTATTATT-3′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′- CTGATGACCAGCAACTTGA-3′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8949280"/>
                  </a:ext>
                </a:extLst>
              </a:tr>
              <a:tr h="488315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2A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′- GCCCGGATAGACTTATTGC-3′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′- CAGCATCTTTGATAGCAGT-3′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2187433"/>
                  </a:ext>
                </a:extLst>
              </a:tr>
            </a:tbl>
          </a:graphicData>
        </a:graphic>
      </p:graphicFrame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39AE8A2C-66BB-464F-9AE0-55C7ACB5E0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7801464"/>
              </p:ext>
            </p:extLst>
          </p:nvPr>
        </p:nvGraphicFramePr>
        <p:xfrm>
          <a:off x="1099047" y="4600203"/>
          <a:ext cx="4883785" cy="4716780"/>
        </p:xfrm>
        <a:graphic>
          <a:graphicData uri="http://schemas.openxmlformats.org/drawingml/2006/table">
            <a:tbl>
              <a:tblPr firstRow="1" firstCol="1" bandRow="1"/>
              <a:tblGrid>
                <a:gridCol w="1137565">
                  <a:extLst>
                    <a:ext uri="{9D8B030D-6E8A-4147-A177-3AD203B41FA5}">
                      <a16:colId xmlns:a16="http://schemas.microsoft.com/office/drawing/2014/main" val="3424433703"/>
                    </a:ext>
                  </a:extLst>
                </a:gridCol>
                <a:gridCol w="3746220">
                  <a:extLst>
                    <a:ext uri="{9D8B030D-6E8A-4147-A177-3AD203B41FA5}">
                      <a16:colId xmlns:a16="http://schemas.microsoft.com/office/drawing/2014/main" val="1088794618"/>
                    </a:ext>
                  </a:extLst>
                </a:gridCol>
              </a:tblGrid>
              <a:tr h="427990">
                <a:tc>
                  <a:txBody>
                    <a:bodyPr/>
                    <a:lstStyle/>
                    <a:p>
                      <a:pPr algn="l"/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name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imer sequences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5564853"/>
                  </a:ext>
                </a:extLst>
              </a:tr>
              <a:tr h="570230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β-actin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 5′ -CCTGGCACCCAGCACAAT -3′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5′ -GCTGATCCACATCTGCTGGAA 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838008"/>
                  </a:ext>
                </a:extLst>
              </a:tr>
              <a:tr h="521970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LC6A8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 5’-GATCACCATGGAGGCGTAG-3’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 5’-TGATCGCCCTGGTTGGA-3′</a:t>
                      </a:r>
                      <a:endParaRPr lang="zh-CN" sz="105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8575489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F-</a:t>
                      </a:r>
                      <a:r>
                        <a:rPr lang="en-US" altLang="zh-CN" sz="12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κ</a:t>
                      </a:r>
                      <a:r>
                        <a:rPr lang="en-US" sz="12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 5'-GCATTCTGACCTTGCCTATCT-3' 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 5'-CTCCAGTCTCCGAGTGAAGC-3'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261086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P53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 5’-GAGCCCCCTCTGAGTCAG-3’</a:t>
                      </a:r>
                    </a:p>
                    <a:p>
                      <a:pPr algn="just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 5’-GCAAAAACATCTTGTTGAG-3’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6206028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TV4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 5'- CCCTGAGAAATTTGAAGGAGAC-3’</a:t>
                      </a:r>
                    </a:p>
                    <a:p>
                      <a:pPr algn="just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 5'- GTCCAGGCAATGAAATGGGCA-3’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0838373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S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 5’-TCTTCCTTCGTCTTCACC-3’</a:t>
                      </a:r>
                    </a:p>
                    <a:p>
                      <a:pPr algn="just"/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 5’-AATCAGAACACACTATTGCC-3’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4297334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A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5′-CTCAAAGTCGGACAGCCTCA-3′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/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5′- CCCTGCAGTAGGTTTCTGCT-3′</a:t>
                      </a:r>
                      <a:endParaRPr lang="zh-CN" alt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8169371"/>
                  </a:ext>
                </a:extLst>
              </a:tr>
              <a:tr h="534670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2A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: 5’-TGAGCTCCCATCTGGACAAG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: 5’-GTCCTGTTAGCTCCACCTGT-3’</a:t>
                      </a:r>
                      <a:endParaRPr lang="zh-CN" sz="105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32621"/>
                  </a:ext>
                </a:extLst>
              </a:tr>
            </a:tbl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93E2F190-8883-4E78-9063-A91AD6440849}"/>
              </a:ext>
            </a:extLst>
          </p:cNvPr>
          <p:cNvSpPr txBox="1"/>
          <p:nvPr/>
        </p:nvSpPr>
        <p:spPr>
          <a:xfrm>
            <a:off x="1048611" y="9294123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te</a:t>
            </a:r>
            <a:r>
              <a:rPr lang="zh-CN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：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: forward primer  R</a:t>
            </a:r>
            <a:r>
              <a:rPr lang="zh-CN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：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verse prim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721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</TotalTime>
  <Words>202</Words>
  <Application>Microsoft Office PowerPoint</Application>
  <PresentationFormat>A4 纸张(210x297 毫米)</PresentationFormat>
  <Paragraphs>4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qiao</dc:creator>
  <cp:lastModifiedBy>li qiao</cp:lastModifiedBy>
  <cp:revision>4</cp:revision>
  <dcterms:created xsi:type="dcterms:W3CDTF">2021-03-07T09:33:11Z</dcterms:created>
  <dcterms:modified xsi:type="dcterms:W3CDTF">2021-03-27T12:48:47Z</dcterms:modified>
</cp:coreProperties>
</file>